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57" r:id="rId3"/>
    <p:sldId id="262" r:id="rId4"/>
    <p:sldId id="258" r:id="rId5"/>
    <p:sldId id="263" r:id="rId6"/>
    <p:sldId id="259" r:id="rId7"/>
    <p:sldId id="260" r:id="rId8"/>
    <p:sldId id="261" r:id="rId9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3399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95" autoAdjust="0"/>
  </p:normalViewPr>
  <p:slideViewPr>
    <p:cSldViewPr snapToGrid="0">
      <p:cViewPr>
        <p:scale>
          <a:sx n="130" d="100"/>
          <a:sy n="130" d="100"/>
        </p:scale>
        <p:origin x="1632" y="-30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image" Target="../media/image3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B7623CA-B2F3-461E-BEBA-B5984A2B72B8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F2C3A59-4690-46BE-9222-A27800984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812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2C3A59-4690-46BE-9222-A2780098420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529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2C3A59-4690-46BE-9222-A2780098420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6731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endParaRPr lang="en-US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2C3A59-4690-46BE-9222-A2780098420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9980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endParaRPr lang="en-US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2C3A59-4690-46BE-9222-A2780098420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928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2C3A59-4690-46BE-9222-A2780098420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072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836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463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284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64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797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425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6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926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900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99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224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D6FD8-6A6E-4078-9A9B-61410A12A7D4}" type="datetimeFigureOut">
              <a:rPr lang="en-US" smtClean="0"/>
              <a:t>4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E26FE-414D-49AD-BD63-12ECA7260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441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6.bin"/><Relationship Id="rId3" Type="http://schemas.openxmlformats.org/officeDocument/2006/relationships/notesSlide" Target="../notesSlides/notesSlide4.xml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8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9.png"/><Relationship Id="rId11" Type="http://schemas.openxmlformats.org/officeDocument/2006/relationships/oleObject" Target="../embeddings/oleObject5.bin"/><Relationship Id="rId5" Type="http://schemas.openxmlformats.org/officeDocument/2006/relationships/image" Target="../media/image13.emf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15.emf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"/><Relationship Id="rId13" Type="http://schemas.openxmlformats.org/officeDocument/2006/relationships/image" Target="../media/image31.tif"/><Relationship Id="rId3" Type="http://schemas.openxmlformats.org/officeDocument/2006/relationships/image" Target="../media/image21.tif"/><Relationship Id="rId7" Type="http://schemas.openxmlformats.org/officeDocument/2006/relationships/image" Target="../media/image25.tif"/><Relationship Id="rId12" Type="http://schemas.openxmlformats.org/officeDocument/2006/relationships/image" Target="../media/image30.tif"/><Relationship Id="rId2" Type="http://schemas.openxmlformats.org/officeDocument/2006/relationships/image" Target="../media/image20.tif"/><Relationship Id="rId16" Type="http://schemas.openxmlformats.org/officeDocument/2006/relationships/image" Target="../media/image34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tif"/><Relationship Id="rId11" Type="http://schemas.openxmlformats.org/officeDocument/2006/relationships/image" Target="../media/image29.tif"/><Relationship Id="rId5" Type="http://schemas.openxmlformats.org/officeDocument/2006/relationships/image" Target="../media/image23.tif"/><Relationship Id="rId15" Type="http://schemas.openxmlformats.org/officeDocument/2006/relationships/image" Target="../media/image33.tif"/><Relationship Id="rId10" Type="http://schemas.openxmlformats.org/officeDocument/2006/relationships/image" Target="../media/image28.tif"/><Relationship Id="rId4" Type="http://schemas.openxmlformats.org/officeDocument/2006/relationships/image" Target="../media/image22.tif"/><Relationship Id="rId9" Type="http://schemas.openxmlformats.org/officeDocument/2006/relationships/image" Target="../media/image27.tif"/><Relationship Id="rId14" Type="http://schemas.openxmlformats.org/officeDocument/2006/relationships/image" Target="../media/image32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39.png"/><Relationship Id="rId12" Type="http://schemas.openxmlformats.org/officeDocument/2006/relationships/image" Target="../media/image3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8.png"/><Relationship Id="rId11" Type="http://schemas.openxmlformats.org/officeDocument/2006/relationships/oleObject" Target="../embeddings/oleObject10.bin"/><Relationship Id="rId5" Type="http://schemas.openxmlformats.org/officeDocument/2006/relationships/image" Target="../media/image35.emf"/><Relationship Id="rId10" Type="http://schemas.openxmlformats.org/officeDocument/2006/relationships/image" Target="../media/image36.emf"/><Relationship Id="rId4" Type="http://schemas.openxmlformats.org/officeDocument/2006/relationships/oleObject" Target="../embeddings/oleObject8.bin"/><Relationship Id="rId9" Type="http://schemas.openxmlformats.org/officeDocument/2006/relationships/oleObject" Target="../embeddings/oleObject9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07D3D1B-4550-5EC9-9EF2-6C3EACC2D8E6}"/>
              </a:ext>
            </a:extLst>
          </p:cNvPr>
          <p:cNvCxnSpPr>
            <a:cxnSpLocks/>
          </p:cNvCxnSpPr>
          <p:nvPr/>
        </p:nvCxnSpPr>
        <p:spPr>
          <a:xfrm>
            <a:off x="1880659" y="571933"/>
            <a:ext cx="0" cy="383025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B494424-CFC1-CEF2-C783-72FC00358FDE}"/>
              </a:ext>
            </a:extLst>
          </p:cNvPr>
          <p:cNvSpPr txBox="1"/>
          <p:nvPr/>
        </p:nvSpPr>
        <p:spPr>
          <a:xfrm>
            <a:off x="1899363" y="612736"/>
            <a:ext cx="74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40ECD01-48C9-A986-B3F0-81B5BD0FA224}"/>
              </a:ext>
            </a:extLst>
          </p:cNvPr>
          <p:cNvCxnSpPr>
            <a:cxnSpLocks/>
          </p:cNvCxnSpPr>
          <p:nvPr/>
        </p:nvCxnSpPr>
        <p:spPr>
          <a:xfrm>
            <a:off x="1995975" y="480011"/>
            <a:ext cx="9144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6FFB8CF6-A1EE-7678-4CF6-8A09EEE93D13}"/>
              </a:ext>
            </a:extLst>
          </p:cNvPr>
          <p:cNvSpPr txBox="1"/>
          <p:nvPr/>
        </p:nvSpPr>
        <p:spPr>
          <a:xfrm>
            <a:off x="483048" y="1419609"/>
            <a:ext cx="17219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ew target seque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AF219C-2A51-1925-D32C-1D66EAABFDBC}"/>
              </a:ext>
            </a:extLst>
          </p:cNvPr>
          <p:cNvSpPr txBox="1"/>
          <p:nvPr/>
        </p:nvSpPr>
        <p:spPr>
          <a:xfrm>
            <a:off x="1963762" y="326122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GG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923455" y="480011"/>
            <a:ext cx="658953" cy="0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C85C7A5-AC3B-25E4-ECB0-7145BAF6C187}"/>
              </a:ext>
            </a:extLst>
          </p:cNvPr>
          <p:cNvCxnSpPr>
            <a:cxnSpLocks/>
          </p:cNvCxnSpPr>
          <p:nvPr/>
        </p:nvCxnSpPr>
        <p:spPr>
          <a:xfrm>
            <a:off x="1821679" y="1100517"/>
            <a:ext cx="91440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080FFC0-9EB1-A286-6192-2B35B9A11520}"/>
              </a:ext>
            </a:extLst>
          </p:cNvPr>
          <p:cNvCxnSpPr>
            <a:cxnSpLocks/>
          </p:cNvCxnSpPr>
          <p:nvPr/>
        </p:nvCxnSpPr>
        <p:spPr>
          <a:xfrm>
            <a:off x="1169550" y="1101154"/>
            <a:ext cx="658953" cy="0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324CC2D-47F4-73DF-7FD9-7C2363BE6688}"/>
              </a:ext>
            </a:extLst>
          </p:cNvPr>
          <p:cNvCxnSpPr>
            <a:cxnSpLocks/>
          </p:cNvCxnSpPr>
          <p:nvPr/>
        </p:nvCxnSpPr>
        <p:spPr>
          <a:xfrm flipV="1">
            <a:off x="1448918" y="1174512"/>
            <a:ext cx="270493" cy="292097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40ECD01-48C9-A986-B3F0-81B5BD0FA224}"/>
              </a:ext>
            </a:extLst>
          </p:cNvPr>
          <p:cNvCxnSpPr>
            <a:cxnSpLocks/>
          </p:cNvCxnSpPr>
          <p:nvPr/>
        </p:nvCxnSpPr>
        <p:spPr>
          <a:xfrm>
            <a:off x="5132320" y="592241"/>
            <a:ext cx="924862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4480191" y="320051"/>
            <a:ext cx="640080" cy="0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1551439" y="475789"/>
            <a:ext cx="457200" cy="0"/>
          </a:xfrm>
          <a:prstGeom prst="line">
            <a:avLst/>
          </a:prstGeom>
          <a:ln w="762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2EAF219C-2A51-1925-D32C-1D66EAABFDBC}"/>
              </a:ext>
            </a:extLst>
          </p:cNvPr>
          <p:cNvSpPr txBox="1"/>
          <p:nvPr/>
        </p:nvSpPr>
        <p:spPr>
          <a:xfrm>
            <a:off x="1784300" y="946628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GG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4493305" y="599065"/>
            <a:ext cx="640080" cy="0"/>
          </a:xfrm>
          <a:prstGeom prst="line">
            <a:avLst/>
          </a:prstGeom>
          <a:ln w="762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EAF219C-2A51-1925-D32C-1D66EAABFDBC}"/>
              </a:ext>
            </a:extLst>
          </p:cNvPr>
          <p:cNvSpPr txBox="1"/>
          <p:nvPr/>
        </p:nvSpPr>
        <p:spPr>
          <a:xfrm>
            <a:off x="5086131" y="444668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GG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5120274" y="320594"/>
            <a:ext cx="914400" cy="0"/>
          </a:xfrm>
          <a:prstGeom prst="line">
            <a:avLst/>
          </a:prstGeom>
          <a:ln w="762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307D3D1B-4550-5EC9-9EF2-6C3EACC2D8E6}"/>
              </a:ext>
            </a:extLst>
          </p:cNvPr>
          <p:cNvCxnSpPr>
            <a:cxnSpLocks/>
          </p:cNvCxnSpPr>
          <p:nvPr/>
        </p:nvCxnSpPr>
        <p:spPr>
          <a:xfrm>
            <a:off x="5211198" y="735641"/>
            <a:ext cx="0" cy="383025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7B494424-CFC1-CEF2-C783-72FC00358FDE}"/>
              </a:ext>
            </a:extLst>
          </p:cNvPr>
          <p:cNvSpPr txBox="1"/>
          <p:nvPr/>
        </p:nvSpPr>
        <p:spPr>
          <a:xfrm>
            <a:off x="5211198" y="752250"/>
            <a:ext cx="1099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location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40ECD01-48C9-A986-B3F0-81B5BD0FA224}"/>
              </a:ext>
            </a:extLst>
          </p:cNvPr>
          <p:cNvCxnSpPr>
            <a:cxnSpLocks/>
          </p:cNvCxnSpPr>
          <p:nvPr/>
        </p:nvCxnSpPr>
        <p:spPr>
          <a:xfrm>
            <a:off x="5156693" y="1267420"/>
            <a:ext cx="924862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096177FF-A067-4CF8-60A0-C7BF26F05A5B}"/>
              </a:ext>
            </a:extLst>
          </p:cNvPr>
          <p:cNvCxnSpPr>
            <a:cxnSpLocks/>
          </p:cNvCxnSpPr>
          <p:nvPr/>
        </p:nvCxnSpPr>
        <p:spPr>
          <a:xfrm>
            <a:off x="4519377" y="1271716"/>
            <a:ext cx="640080" cy="0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2EAF219C-2A51-1925-D32C-1D66EAABFDBC}"/>
              </a:ext>
            </a:extLst>
          </p:cNvPr>
          <p:cNvSpPr txBox="1"/>
          <p:nvPr/>
        </p:nvSpPr>
        <p:spPr>
          <a:xfrm>
            <a:off x="5116608" y="1119440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G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FFB8CF6-A1EE-7678-4CF6-8A09EEE93D13}"/>
              </a:ext>
            </a:extLst>
          </p:cNvPr>
          <p:cNvSpPr txBox="1"/>
          <p:nvPr/>
        </p:nvSpPr>
        <p:spPr>
          <a:xfrm>
            <a:off x="3892460" y="1606842"/>
            <a:ext cx="17219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ew target sequence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324CC2D-47F4-73DF-7FD9-7C2363BE6688}"/>
              </a:ext>
            </a:extLst>
          </p:cNvPr>
          <p:cNvCxnSpPr>
            <a:cxnSpLocks/>
          </p:cNvCxnSpPr>
          <p:nvPr/>
        </p:nvCxnSpPr>
        <p:spPr>
          <a:xfrm flipV="1">
            <a:off x="4858330" y="1361745"/>
            <a:ext cx="270493" cy="292097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11" descr="Chart&#10;&#10;Description automatically generated">
            <a:extLst>
              <a:ext uri="{FF2B5EF4-FFF2-40B4-BE49-F238E27FC236}">
                <a16:creationId xmlns:a16="http://schemas.microsoft.com/office/drawing/2014/main" id="{DC309B3B-F8C2-4A66-9CE8-700CDF4424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288" t="13974" r="21848"/>
          <a:stretch/>
        </p:blipFill>
        <p:spPr>
          <a:xfrm>
            <a:off x="1859972" y="4177389"/>
            <a:ext cx="3796938" cy="771596"/>
          </a:xfrm>
          <a:prstGeom prst="rect">
            <a:avLst/>
          </a:prstGeom>
        </p:spPr>
      </p:pic>
      <p:grpSp>
        <p:nvGrpSpPr>
          <p:cNvPr id="71" name="Group 70"/>
          <p:cNvGrpSpPr/>
          <p:nvPr/>
        </p:nvGrpSpPr>
        <p:grpSpPr>
          <a:xfrm>
            <a:off x="3643930" y="2286948"/>
            <a:ext cx="3851879" cy="1518698"/>
            <a:chOff x="3875313" y="4327867"/>
            <a:chExt cx="3851879" cy="1518698"/>
          </a:xfrm>
        </p:grpSpPr>
        <p:pic>
          <p:nvPicPr>
            <p:cNvPr id="61" name="Picture 60"/>
            <p:cNvPicPr>
              <a:picLocks noChangeAspect="1"/>
            </p:cNvPicPr>
            <p:nvPr/>
          </p:nvPicPr>
          <p:blipFill rotWithShape="1">
            <a:blip r:embed="rId4"/>
            <a:srcRect l="23705" r="857" b="35107"/>
            <a:stretch/>
          </p:blipFill>
          <p:spPr>
            <a:xfrm>
              <a:off x="3915109" y="5166653"/>
              <a:ext cx="3779520" cy="679912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5"/>
            <a:srcRect l="26205"/>
            <a:stretch/>
          </p:blipFill>
          <p:spPr>
            <a:xfrm>
              <a:off x="3875313" y="4327867"/>
              <a:ext cx="3851879" cy="819150"/>
            </a:xfrm>
            <a:prstGeom prst="rect">
              <a:avLst/>
            </a:prstGeom>
          </p:spPr>
        </p:pic>
      </p:grpSp>
      <p:grpSp>
        <p:nvGrpSpPr>
          <p:cNvPr id="70" name="Group 69"/>
          <p:cNvGrpSpPr/>
          <p:nvPr/>
        </p:nvGrpSpPr>
        <p:grpSpPr>
          <a:xfrm>
            <a:off x="911755" y="2280687"/>
            <a:ext cx="2708366" cy="1727735"/>
            <a:chOff x="-95794" y="4327868"/>
            <a:chExt cx="2708366" cy="1727735"/>
          </a:xfrm>
        </p:grpSpPr>
        <p:pic>
          <p:nvPicPr>
            <p:cNvPr id="56" name="Picture 55"/>
            <p:cNvPicPr>
              <a:picLocks noChangeAspect="1"/>
            </p:cNvPicPr>
            <p:nvPr/>
          </p:nvPicPr>
          <p:blipFill rotWithShape="1">
            <a:blip r:embed="rId6"/>
            <a:srcRect l="29551" r="22499" b="69625"/>
            <a:stretch/>
          </p:blipFill>
          <p:spPr>
            <a:xfrm>
              <a:off x="-95794" y="4327868"/>
              <a:ext cx="2708366" cy="784064"/>
            </a:xfrm>
            <a:prstGeom prst="rect">
              <a:avLst/>
            </a:prstGeom>
          </p:spPr>
        </p:pic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7"/>
            <a:srcRect l="30707" r="27489" b="56151"/>
            <a:stretch/>
          </p:blipFill>
          <p:spPr>
            <a:xfrm>
              <a:off x="-87090" y="5147018"/>
              <a:ext cx="2699662" cy="722560"/>
            </a:xfrm>
            <a:prstGeom prst="rect">
              <a:avLst/>
            </a:prstGeom>
          </p:spPr>
        </p:pic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7"/>
            <a:srcRect l="30707" t="87541" r="27489"/>
            <a:stretch/>
          </p:blipFill>
          <p:spPr>
            <a:xfrm>
              <a:off x="-87090" y="5850306"/>
              <a:ext cx="2699662" cy="205297"/>
            </a:xfrm>
            <a:prstGeom prst="rect">
              <a:avLst/>
            </a:prstGeom>
          </p:spPr>
        </p:pic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102E71BA-A8B3-1B2E-FF22-17A47A1E6179}"/>
              </a:ext>
            </a:extLst>
          </p:cNvPr>
          <p:cNvSpPr txBox="1"/>
          <p:nvPr/>
        </p:nvSpPr>
        <p:spPr>
          <a:xfrm>
            <a:off x="119282" y="42289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BB76A20-F179-AA4F-6E70-AC4AF1E4926A}"/>
              </a:ext>
            </a:extLst>
          </p:cNvPr>
          <p:cNvSpPr txBox="1"/>
          <p:nvPr/>
        </p:nvSpPr>
        <p:spPr>
          <a:xfrm>
            <a:off x="3514707" y="0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02E71BA-A8B3-1B2E-FF22-17A47A1E6179}"/>
              </a:ext>
            </a:extLst>
          </p:cNvPr>
          <p:cNvSpPr txBox="1"/>
          <p:nvPr/>
        </p:nvSpPr>
        <p:spPr>
          <a:xfrm>
            <a:off x="-1427" y="1896783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02158" y="2595157"/>
            <a:ext cx="622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274457" y="3363015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577288" y="2039698"/>
            <a:ext cx="13773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1:248,741,764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923698" y="2045681"/>
            <a:ext cx="1292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9:69,948,900</a:t>
            </a:r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4"/>
          <a:srcRect l="22911" t="77864" r="1552" b="2778"/>
          <a:stretch/>
        </p:blipFill>
        <p:spPr>
          <a:xfrm>
            <a:off x="3678765" y="3803126"/>
            <a:ext cx="3784482" cy="202818"/>
          </a:xfrm>
          <a:prstGeom prst="rect">
            <a:avLst/>
          </a:prstGeom>
        </p:spPr>
      </p:pic>
      <p:sp>
        <p:nvSpPr>
          <p:cNvPr id="79" name="Rectangle 78">
            <a:extLst>
              <a:ext uri="{FF2B5EF4-FFF2-40B4-BE49-F238E27FC236}">
                <a16:creationId xmlns:a16="http://schemas.microsoft.com/office/drawing/2014/main" id="{3B4EE9A4-89AB-9E70-C0A0-5E2E16BD2BB5}"/>
              </a:ext>
            </a:extLst>
          </p:cNvPr>
          <p:cNvSpPr/>
          <p:nvPr/>
        </p:nvSpPr>
        <p:spPr>
          <a:xfrm>
            <a:off x="911753" y="2281048"/>
            <a:ext cx="2699662" cy="81879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8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3B4EE9A4-89AB-9E70-C0A0-5E2E16BD2BB5}"/>
              </a:ext>
            </a:extLst>
          </p:cNvPr>
          <p:cNvSpPr/>
          <p:nvPr/>
        </p:nvSpPr>
        <p:spPr>
          <a:xfrm>
            <a:off x="3650608" y="2285401"/>
            <a:ext cx="3836494" cy="172737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8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3B4EE9A4-89AB-9E70-C0A0-5E2E16BD2BB5}"/>
              </a:ext>
            </a:extLst>
          </p:cNvPr>
          <p:cNvSpPr/>
          <p:nvPr/>
        </p:nvSpPr>
        <p:spPr>
          <a:xfrm>
            <a:off x="917090" y="3099836"/>
            <a:ext cx="2699662" cy="9042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8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3B4EE9A4-89AB-9E70-C0A0-5E2E16BD2BB5}"/>
              </a:ext>
            </a:extLst>
          </p:cNvPr>
          <p:cNvSpPr/>
          <p:nvPr/>
        </p:nvSpPr>
        <p:spPr>
          <a:xfrm>
            <a:off x="3649267" y="3090573"/>
            <a:ext cx="3836494" cy="9240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8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1169550" y="3848774"/>
            <a:ext cx="1035444" cy="14658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4396080" y="3861835"/>
            <a:ext cx="1035444" cy="14658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6838827" y="3848774"/>
            <a:ext cx="652279" cy="155287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87"/>
          <p:cNvSpPr txBox="1"/>
          <p:nvPr/>
        </p:nvSpPr>
        <p:spPr>
          <a:xfrm>
            <a:off x="714503" y="4387184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nger traces</a:t>
            </a:r>
          </a:p>
        </p:txBody>
      </p:sp>
      <p:sp>
        <p:nvSpPr>
          <p:cNvPr id="89" name="Rectangle 88"/>
          <p:cNvSpPr/>
          <p:nvPr/>
        </p:nvSpPr>
        <p:spPr>
          <a:xfrm>
            <a:off x="5150631" y="4175514"/>
            <a:ext cx="506279" cy="773471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3126208" y="4174911"/>
            <a:ext cx="914569" cy="7740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261893" y="5200760"/>
            <a:ext cx="7233915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Structural variants create novel CRISPR-Cas9 target site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ructural variants, such as (A) deletion and (B) translocation, could give rise to novel target sequence if the new junction is 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proximit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an existing NGG PAM (shown) or creates a new PAM (not shown). For example, (C) a chr1:chr9 translocation in Panc480 gave rise to a novel breakpoint that was in proximity of an existing AGG PAM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reen box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is breakpoint was characterized by a 5bp GGAGC microhomology at its junct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red box)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9552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C099388-8FD3-6BB7-B19C-2AB581890F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837" y="983854"/>
            <a:ext cx="3257006" cy="7747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6117" y="129477"/>
            <a:ext cx="3817643" cy="276640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9EF942E-99C8-97D6-445F-1B50DA7AE6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837" y="3548765"/>
            <a:ext cx="3257006" cy="79271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36117" y="3042661"/>
            <a:ext cx="3817643" cy="188867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0837" y="6895420"/>
            <a:ext cx="3257006" cy="77718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36116" y="4951304"/>
            <a:ext cx="3817643" cy="4665423"/>
          </a:xfrm>
          <a:prstGeom prst="rect">
            <a:avLst/>
          </a:prstGeom>
        </p:spPr>
      </p:pic>
      <p:sp>
        <p:nvSpPr>
          <p:cNvPr id="11" name="Left Brace 10"/>
          <p:cNvSpPr/>
          <p:nvPr/>
        </p:nvSpPr>
        <p:spPr>
          <a:xfrm>
            <a:off x="3475248" y="167929"/>
            <a:ext cx="360869" cy="2727956"/>
          </a:xfrm>
          <a:prstGeom prst="lef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2E71BA-A8B3-1B2E-FF22-17A47A1E6179}"/>
              </a:ext>
            </a:extLst>
          </p:cNvPr>
          <p:cNvSpPr txBox="1"/>
          <p:nvPr/>
        </p:nvSpPr>
        <p:spPr>
          <a:xfrm>
            <a:off x="18494" y="0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02E71BA-A8B3-1B2E-FF22-17A47A1E6179}"/>
              </a:ext>
            </a:extLst>
          </p:cNvPr>
          <p:cNvSpPr txBox="1"/>
          <p:nvPr/>
        </p:nvSpPr>
        <p:spPr>
          <a:xfrm>
            <a:off x="18493" y="2949643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Left Brace 13"/>
          <p:cNvSpPr/>
          <p:nvPr/>
        </p:nvSpPr>
        <p:spPr>
          <a:xfrm>
            <a:off x="3475248" y="4969769"/>
            <a:ext cx="360869" cy="4646958"/>
          </a:xfrm>
          <a:prstGeom prst="lef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02E71BA-A8B3-1B2E-FF22-17A47A1E6179}"/>
              </a:ext>
            </a:extLst>
          </p:cNvPr>
          <p:cNvSpPr txBox="1"/>
          <p:nvPr/>
        </p:nvSpPr>
        <p:spPr>
          <a:xfrm>
            <a:off x="100837" y="4951305"/>
            <a:ext cx="11709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Left Brace 15"/>
          <p:cNvSpPr/>
          <p:nvPr/>
        </p:nvSpPr>
        <p:spPr>
          <a:xfrm>
            <a:off x="3475248" y="3042661"/>
            <a:ext cx="360869" cy="1888676"/>
          </a:xfrm>
          <a:prstGeom prst="leftBrac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267473" y="8554894"/>
            <a:ext cx="3207774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Mutational signature analyses indicated predominant aging signatures in PC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st SBS mutational signatures found in (A) Panc480, (B) Panc504, and (C) Panc1002 were associated with clock-like signatures. The only exception was SBS18 found in Panc1002, which was linked to possible damage by reactive oxygen species. Y-axis is the percentage of SBS. </a:t>
            </a:r>
          </a:p>
        </p:txBody>
      </p:sp>
    </p:spTree>
    <p:extLst>
      <p:ext uri="{BB962C8B-B14F-4D97-AF65-F5344CB8AC3E}">
        <p14:creationId xmlns:p14="http://schemas.microsoft.com/office/powerpoint/2010/main" val="5348229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/>
          <p:cNvSpPr/>
          <p:nvPr/>
        </p:nvSpPr>
        <p:spPr>
          <a:xfrm>
            <a:off x="685799" y="6048608"/>
            <a:ext cx="641283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reased number of </a:t>
            </a:r>
            <a:r>
              <a:rPr lang="en-US" sz="1000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arget sites increased cytotoxicity in PC cells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owt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hibition of two PC cell lines, Panc10.05 and TS0111, treated with non-target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NT and NT2), 3-, 5-, 8-, 12-, and 14-target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repetitive region-target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L1.4_209F, ALU_112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and measured for cytotoxicity using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amarBlu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ssay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3; mean ± SEM are shown. 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1898463"/>
              </p:ext>
            </p:extLst>
          </p:nvPr>
        </p:nvGraphicFramePr>
        <p:xfrm>
          <a:off x="2146201" y="3162594"/>
          <a:ext cx="3777459" cy="25174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4" name="Prism 10" r:id="rId4" imgW="4697250" imgH="3130099" progId="Prism10.Document">
                  <p:embed/>
                </p:oleObj>
              </mc:Choice>
              <mc:Fallback>
                <p:oleObj name="Prism 10" r:id="rId4" imgW="4697250" imgH="3130099" progId="Prism10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46201" y="3162594"/>
                        <a:ext cx="3777459" cy="25174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42000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F937EB5-7B36-40D7-BFD5-CB2A58805F04}"/>
              </a:ext>
            </a:extLst>
          </p:cNvPr>
          <p:cNvSpPr txBox="1"/>
          <p:nvPr/>
        </p:nvSpPr>
        <p:spPr>
          <a:xfrm>
            <a:off x="484822" y="157163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71F9441-47B4-4514-89DB-D7C8944E2029}"/>
              </a:ext>
            </a:extLst>
          </p:cNvPr>
          <p:cNvSpPr txBox="1"/>
          <p:nvPr/>
        </p:nvSpPr>
        <p:spPr>
          <a:xfrm>
            <a:off x="499729" y="2295257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9D17F2-4EFA-4506-870D-942F55DB0C1B}"/>
              </a:ext>
            </a:extLst>
          </p:cNvPr>
          <p:cNvSpPr txBox="1"/>
          <p:nvPr/>
        </p:nvSpPr>
        <p:spPr>
          <a:xfrm>
            <a:off x="3882523" y="94542"/>
            <a:ext cx="3765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B7E4A05-84BB-4D83-8151-62B99CD4F91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89630" y="3744871"/>
          <a:ext cx="3061405" cy="21384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0" name="Prism 9" r:id="rId4" imgW="3860295" imgH="2698634" progId="Prism9.Document">
                  <p:embed/>
                </p:oleObj>
              </mc:Choice>
              <mc:Fallback>
                <p:oleObj name="Prism 9" r:id="rId4" imgW="3860295" imgH="2698634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B7E4A05-84BB-4D83-8151-62B99CD4F9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89630" y="3744871"/>
                        <a:ext cx="3061405" cy="21384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" name="Group 14"/>
          <p:cNvGrpSpPr/>
          <p:nvPr/>
        </p:nvGrpSpPr>
        <p:grpSpPr>
          <a:xfrm>
            <a:off x="1075648" y="2398638"/>
            <a:ext cx="5590074" cy="1243094"/>
            <a:chOff x="1150047" y="256777"/>
            <a:chExt cx="4815280" cy="117198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6349EE3A-06BA-4ACF-8244-08ED7F35CE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371" r="5614"/>
            <a:stretch/>
          </p:blipFill>
          <p:spPr>
            <a:xfrm>
              <a:off x="1150047" y="266715"/>
              <a:ext cx="4815280" cy="116205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712419C-3443-4E52-B4FB-F40F025E40C6}"/>
                </a:ext>
              </a:extLst>
            </p:cNvPr>
            <p:cNvSpPr txBox="1"/>
            <p:nvPr/>
          </p:nvSpPr>
          <p:spPr>
            <a:xfrm>
              <a:off x="2439720" y="823887"/>
              <a:ext cx="405903" cy="56067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7DA9489-923B-406D-89FB-60545E11DF97}"/>
                </a:ext>
              </a:extLst>
            </p:cNvPr>
            <p:cNvSpPr txBox="1"/>
            <p:nvPr/>
          </p:nvSpPr>
          <p:spPr>
            <a:xfrm>
              <a:off x="5032082" y="256777"/>
              <a:ext cx="308238" cy="56067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4DA26FF-3A62-40E5-B699-F79C2F9E5311}"/>
                </a:ext>
              </a:extLst>
            </p:cNvPr>
            <p:cNvSpPr txBox="1"/>
            <p:nvPr/>
          </p:nvSpPr>
          <p:spPr>
            <a:xfrm>
              <a:off x="1881277" y="817454"/>
              <a:ext cx="514230" cy="56067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D3EC969-541F-4938-9689-BB73F6AC633D}"/>
                </a:ext>
              </a:extLst>
            </p:cNvPr>
            <p:cNvSpPr/>
            <p:nvPr/>
          </p:nvSpPr>
          <p:spPr>
            <a:xfrm>
              <a:off x="5008228" y="847740"/>
              <a:ext cx="570451" cy="5606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340956CC-9450-499F-AFD2-567E042DDE3C}"/>
                </a:ext>
              </a:extLst>
            </p:cNvPr>
            <p:cNvCxnSpPr>
              <a:cxnSpLocks/>
            </p:cNvCxnSpPr>
            <p:nvPr/>
          </p:nvCxnSpPr>
          <p:spPr>
            <a:xfrm>
              <a:off x="1546383" y="478062"/>
              <a:ext cx="162444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ADB26F8C-D006-4966-9081-B0026C577A5B}"/>
                </a:ext>
              </a:extLst>
            </p:cNvPr>
            <p:cNvCxnSpPr>
              <a:cxnSpLocks/>
            </p:cNvCxnSpPr>
            <p:nvPr/>
          </p:nvCxnSpPr>
          <p:spPr>
            <a:xfrm>
              <a:off x="3095538" y="1030283"/>
              <a:ext cx="162444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AF08F97-DE1F-2B83-DF3C-BFD5570EDD5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895361" y="3673855"/>
          <a:ext cx="3131616" cy="2174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1" name="Prism 9" r:id="rId7" imgW="3913595" imgH="2716196" progId="Prism9.Document">
                  <p:embed/>
                </p:oleObj>
              </mc:Choice>
              <mc:Fallback>
                <p:oleObj name="Prism 9" r:id="rId7" imgW="3913595" imgH="2716196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AF08F97-DE1F-2B83-DF3C-BFD5570EDD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95361" y="3673855"/>
                        <a:ext cx="3131616" cy="2174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3748A6D-3A0E-18E9-C653-CA66D28FFEA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875683" y="5945732"/>
          <a:ext cx="3509963" cy="2058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2" name="Prism 9" r:id="rId9" imgW="5020292" imgH="2671910" progId="Prism9.Document">
                  <p:embed/>
                </p:oleObj>
              </mc:Choice>
              <mc:Fallback>
                <p:oleObj name="Prism 9" r:id="rId9" imgW="5020292" imgH="2671910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3748A6D-3A0E-18E9-C653-CA66D28FFE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75683" y="5945732"/>
                        <a:ext cx="3509963" cy="2058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E261989-8F3B-B68C-9D4B-2A42587F32C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89630" y="5844870"/>
          <a:ext cx="2111051" cy="2007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3" name="Prism 9" r:id="rId11" imgW="2376896" imgH="2552412" progId="Prism9.Document">
                  <p:embed/>
                </p:oleObj>
              </mc:Choice>
              <mc:Fallback>
                <p:oleObj name="Prism 9" r:id="rId11" imgW="2376896" imgH="2552412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E261989-8F3B-B68C-9D4B-2A42587F32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89630" y="5844870"/>
                        <a:ext cx="2111051" cy="2007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51513FE-7687-A47C-46A4-965D98C72363}"/>
              </a:ext>
            </a:extLst>
          </p:cNvPr>
          <p:cNvSpPr txBox="1"/>
          <p:nvPr/>
        </p:nvSpPr>
        <p:spPr>
          <a:xfrm>
            <a:off x="518270" y="3674670"/>
            <a:ext cx="495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7A2D89-7952-55B7-0285-28A9B3F76354}"/>
              </a:ext>
            </a:extLst>
          </p:cNvPr>
          <p:cNvSpPr txBox="1"/>
          <p:nvPr/>
        </p:nvSpPr>
        <p:spPr>
          <a:xfrm>
            <a:off x="3626463" y="3627850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640975A-1148-BF3A-1C0B-6EBD6F9B8793}"/>
              </a:ext>
            </a:extLst>
          </p:cNvPr>
          <p:cNvSpPr txBox="1"/>
          <p:nvPr/>
        </p:nvSpPr>
        <p:spPr>
          <a:xfrm>
            <a:off x="544162" y="5810441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24" name="Object 23"/>
          <p:cNvGraphicFramePr>
            <a:graphicFrameLocks noChangeAspect="1"/>
          </p:cNvGraphicFramePr>
          <p:nvPr>
            <p:extLst/>
          </p:nvPr>
        </p:nvGraphicFramePr>
        <p:xfrm>
          <a:off x="815742" y="157163"/>
          <a:ext cx="2913345" cy="2241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4" name="Prism 9" r:id="rId13" imgW="4021996" imgH="3094245" progId="Prism9.Document">
                  <p:embed/>
                </p:oleObj>
              </mc:Choice>
              <mc:Fallback>
                <p:oleObj name="Prism 9" r:id="rId13" imgW="4021996" imgH="3094245" progId="Prism9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15742" y="157163"/>
                        <a:ext cx="2913345" cy="2241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/>
          </p:nvPr>
        </p:nvGraphicFramePr>
        <p:xfrm>
          <a:off x="4210763" y="179730"/>
          <a:ext cx="2693987" cy="223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5" name="Prism 9" r:id="rId15" imgW="3758016" imgH="3114048" progId="Prism9.Document">
                  <p:embed/>
                </p:oleObj>
              </mc:Choice>
              <mc:Fallback>
                <p:oleObj name="Prism 9" r:id="rId15" imgW="3758016" imgH="3114048" progId="Prism9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210763" y="179730"/>
                        <a:ext cx="2693987" cy="2232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B640975A-1148-BF3A-1C0B-6EBD6F9B8793}"/>
              </a:ext>
            </a:extLst>
          </p:cNvPr>
          <p:cNvSpPr txBox="1"/>
          <p:nvPr/>
        </p:nvSpPr>
        <p:spPr>
          <a:xfrm>
            <a:off x="3705974" y="5844870"/>
            <a:ext cx="6202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7" name="Rectangle 26"/>
          <p:cNvSpPr/>
          <p:nvPr/>
        </p:nvSpPr>
        <p:spPr>
          <a:xfrm>
            <a:off x="223405" y="7949597"/>
            <a:ext cx="7351102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.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uman cell line-specific toxicity was reproducible across different combinations of mouse-human co-cultures, and this selective cell elimination required the presence of both Cas9 and human-specific 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-B) Cas9 activity assay was performed on (A) PC Cas9-expressing cell lines (Panc10.05, TS0111) and (B) mouse Cas9-expressing cell lines (NIH 3T3 and Panc02) to quantify mutation frequency at the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PRT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locus. (C) Alignment of the mouse and human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C3H2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thologs shows differences of a 3bp indel and 3 SNPs between the two species, highlighted by red boxes. PCR primer sequences are underlined. (D) Sensitivity and accuracy of the mouse-human NGS assay was validated by deep sequencing known mixes of mouse and human DNA. Pearson r = 0.9941,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&lt;0.000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N=3. (E) TS0111 and NIH 3T3 Cas9-expressing cell lines were co-cultured and transduced with 230F(12). Shown are the changes in TS0111 cell population over time by flow cytometry (based on fluorophore expression) and the  mouse-human NGS assay. (F) Panc10.05 and Panc02 Cas9-expressing cell lines were also co-cultured and transduced with the same sgRNA, in which the change in Panc10.05 cell population was measured by flow cytometry. Panc02 is a KPC-derived mouse cell line. (G) NIH 3T3 Cas9-expressing cell line was co-cultured with either Panc10.05 parental, dCas9-expressing cell line, or Cas9-expressing cell line, and transduced with 230F(12), in which the change in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nc10.05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population was measured by flow cytometry. For E-G, error bars indicate mean ± SEM; N=3.</a:t>
            </a:r>
          </a:p>
        </p:txBody>
      </p:sp>
    </p:spTree>
    <p:extLst>
      <p:ext uri="{BB962C8B-B14F-4D97-AF65-F5344CB8AC3E}">
        <p14:creationId xmlns:p14="http://schemas.microsoft.com/office/powerpoint/2010/main" val="7081110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blue ovals on a black background&#10;&#10;Description automatically generated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66672" y="591790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A red spots on a black background&#10;&#10;Description automatically generated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54096" y="591790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41520" y="591790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A blurry image of blue circles&#10;&#10;Description automatically generated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66672" y="2091406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A red spots on a black background&#10;&#10;Description automatically generated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54096" y="2091406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A group of red dots&#10;&#10;Description automatically generated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41520" y="2091406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 descr="A blue circles in a black background&#10;&#10;Description automatically generated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66672" y="3591022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/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63240" y="3591022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 descr="A pair of blue circles&#10;&#10;Description automatically generated"/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41520" y="3591022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 descr="A blurry image of a blue circle&#10;&#10;Description automatically generated"/>
          <p:cNvPicPr/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66672" y="5090638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 descr="Red spots on a black background&#10;&#10;Description automatically generated"/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54096" y="5090638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 descr="A red and blue lights&#10;&#10;Description automatically generated with medium confidence"/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41520" y="5090638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 descr="A blue light on a black background&#10;&#10;Description automatically generated"/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66672" y="6590254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 descr="A red glowing object on a black background&#10;&#10;Description automatically generated"/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54096" y="6590254"/>
            <a:ext cx="1371600" cy="1371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 descr="A close-up of a cell&#10;&#10;Description automatically generated"/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41520" y="6590254"/>
            <a:ext cx="1371600" cy="1371600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TextBox 16"/>
          <p:cNvSpPr txBox="1"/>
          <p:nvPr/>
        </p:nvSpPr>
        <p:spPr>
          <a:xfrm>
            <a:off x="2004840" y="348143"/>
            <a:ext cx="495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API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431020" y="348143"/>
            <a:ext cx="653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γH2A.X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902712" y="348142"/>
            <a:ext cx="6813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Merged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1073922" y="1169134"/>
            <a:ext cx="796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NT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786633" y="2642234"/>
            <a:ext cx="840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4 </a:t>
            </a:r>
            <a:r>
              <a:rPr lang="en-US" sz="1200" b="1" dirty="0" err="1" smtClean="0"/>
              <a:t>sgRNAs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786632" y="4141850"/>
            <a:ext cx="840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</a:t>
            </a:r>
            <a:r>
              <a:rPr lang="en-US" sz="1200" b="1" dirty="0" smtClean="0"/>
              <a:t> </a:t>
            </a:r>
            <a:r>
              <a:rPr lang="en-US" sz="1200" b="1" dirty="0" err="1" smtClean="0"/>
              <a:t>sgRNAs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786632" y="5647982"/>
            <a:ext cx="840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 </a:t>
            </a:r>
            <a:r>
              <a:rPr lang="en-US" sz="1200" b="1" dirty="0" err="1" smtClean="0"/>
              <a:t>sgRNAs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934035" y="7137554"/>
            <a:ext cx="840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/>
              <a:t>AGGn</a:t>
            </a:r>
            <a:endParaRPr lang="en-US" sz="1200" b="1" dirty="0"/>
          </a:p>
        </p:txBody>
      </p:sp>
      <p:sp>
        <p:nvSpPr>
          <p:cNvPr id="26" name="Rectangle 25"/>
          <p:cNvSpPr/>
          <p:nvPr/>
        </p:nvSpPr>
        <p:spPr>
          <a:xfrm>
            <a:off x="342337" y="8089869"/>
            <a:ext cx="7020483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5. TS0111-specific </a:t>
            </a:r>
            <a:r>
              <a:rPr lang="en-US" sz="1000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s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d not produce significant number of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H2A.X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ci in Panc10.05 cells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γH2A.X staining 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nc10.05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transduced 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ith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n targeting (NT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rgeting 4, 7 or 9 TS0111-specific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tes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GG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as used as a positive control. Cells were stained for γH2A.X two days after transduction. Images were acquired a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X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gnification. Scale bar is 5µM. </a:t>
            </a:r>
          </a:p>
          <a:p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000" dirty="0" smtClean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72955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E42A762-C0F3-384B-C1B0-8BD5A513BABA}"/>
              </a:ext>
            </a:extLst>
          </p:cNvPr>
          <p:cNvSpPr txBox="1"/>
          <p:nvPr/>
        </p:nvSpPr>
        <p:spPr>
          <a:xfrm>
            <a:off x="156113" y="39307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94DA815-1026-63EB-8433-F16DE3187765}"/>
              </a:ext>
            </a:extLst>
          </p:cNvPr>
          <p:cNvSpPr txBox="1"/>
          <p:nvPr/>
        </p:nvSpPr>
        <p:spPr>
          <a:xfrm>
            <a:off x="154549" y="1610101"/>
            <a:ext cx="3765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AB111C9-14DE-9193-4059-C8124282A5D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0078" y="1661399"/>
          <a:ext cx="3461532" cy="30262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0" name="Prism 9" r:id="rId4" imgW="3774943" imgH="3299832" progId="Prism9.Document">
                  <p:embed/>
                </p:oleObj>
              </mc:Choice>
              <mc:Fallback>
                <p:oleObj name="Prism 9" r:id="rId4" imgW="3774943" imgH="329983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AB111C9-14DE-9193-4059-C8124282A5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0078" y="1661399"/>
                        <a:ext cx="3461532" cy="30262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607" y="258763"/>
            <a:ext cx="5954029" cy="132388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82179" y="7084650"/>
            <a:ext cx="702048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6. Panc10.05-specific </a:t>
            </a:r>
            <a:r>
              <a:rPr lang="en-US" sz="1000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s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duced on-target 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tations and selective toxicity against Panc10.05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Illustration of Panc10.05 quad vector. The vector was designed to express 4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argeting Panc10.05 simultaneously. Diagram was generated by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napGene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B) Panc10.05 quad was transduced into Panc10.05 and a negative control cell line (Panc480), and mutation frequency was quantified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1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ys post transduction using deep sequencing and CRISPResso2.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=1/2; mean ±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EM. (C) Panc10.05 quad and NT quad (negative control) were transduced into Panc10.05 and plated on 96-well plates for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lonogenic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growth, and growth inhibition was measured on day 21 post transduction relative to NT quad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N=3; mean ± SEM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D-E) Co-cultures of Panc10.05 (labeled with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NeonGreen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nd TS0111 cell mixtures were transduced with pool of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(4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per pool) that included either the same set of Panc10.05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used in Panc10.05 quad (Panc10.05 pool) or non-targeting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ontrols (NT pool). (D) Percentage reductions of Panc10.05 pool relative to NT pool on day 1 and day 21 post transduction of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ere shown. N=3;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ean ±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EM. (E)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low cytometry analyses of one replicate on day 21 post transductions were shown. Left panel is cells treated with NT pool and right panel is with Panc10.05 pool. </a:t>
            </a:r>
            <a:endParaRPr lang="en-US" sz="1000" dirty="0" smtClean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F565FB-9F0D-F726-8363-88E07B994374}"/>
              </a:ext>
            </a:extLst>
          </p:cNvPr>
          <p:cNvSpPr txBox="1"/>
          <p:nvPr/>
        </p:nvSpPr>
        <p:spPr>
          <a:xfrm>
            <a:off x="3930319" y="1592517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1F565FB-9F0D-F726-8363-88E07B994374}"/>
              </a:ext>
            </a:extLst>
          </p:cNvPr>
          <p:cNvSpPr txBox="1"/>
          <p:nvPr/>
        </p:nvSpPr>
        <p:spPr>
          <a:xfrm>
            <a:off x="-31188" y="4653225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004184" y="5088890"/>
            <a:ext cx="4727728" cy="1893914"/>
            <a:chOff x="471801" y="4944354"/>
            <a:chExt cx="4727728" cy="1893914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7"/>
            <a:srcRect l="8216" t="18428" r="11297" b="9455"/>
            <a:stretch/>
          </p:blipFill>
          <p:spPr>
            <a:xfrm>
              <a:off x="685607" y="4944354"/>
              <a:ext cx="2212786" cy="1647693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8"/>
            <a:srcRect l="7796" t="17924" r="10699" b="9943"/>
            <a:stretch/>
          </p:blipFill>
          <p:spPr>
            <a:xfrm>
              <a:off x="3079783" y="4974592"/>
              <a:ext cx="2119746" cy="1637475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1060616" y="6592047"/>
              <a:ext cx="160172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58547" y="5549627"/>
              <a:ext cx="10727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rward scatter</a:t>
              </a:r>
              <a:endParaRPr lang="en-US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363541" y="5360780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37.04%</a:t>
              </a:r>
              <a:endParaRPr lang="en-US" sz="1000" dirty="0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2015899" y="5136372"/>
              <a:ext cx="589842" cy="36198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091347" y="5333986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66.42%</a:t>
              </a:r>
              <a:endParaRPr lang="en-US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487589" y="6592047"/>
              <a:ext cx="160172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2485139" y="5526818"/>
              <a:ext cx="10727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rward scatter</a:t>
              </a:r>
              <a:endParaRPr lang="en-US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4633940"/>
              </p:ext>
            </p:extLst>
          </p:nvPr>
        </p:nvGraphicFramePr>
        <p:xfrm>
          <a:off x="4388776" y="1627686"/>
          <a:ext cx="2008187" cy="3144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1" name="Prism 10" r:id="rId9" imgW="2007757" imgH="3145225" progId="Prism10.Document">
                  <p:embed/>
                </p:oleObj>
              </mc:Choice>
              <mc:Fallback>
                <p:oleObj name="Prism 10" r:id="rId9" imgW="2007757" imgH="3145225" progId="Prism10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388776" y="1627686"/>
                        <a:ext cx="2008187" cy="3144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29282"/>
              </p:ext>
            </p:extLst>
          </p:nvPr>
        </p:nvGraphicFramePr>
        <p:xfrm>
          <a:off x="48813" y="4965147"/>
          <a:ext cx="2955371" cy="20384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Prism 10" r:id="rId11" imgW="3556700" imgH="2453009" progId="Prism10.Document">
                  <p:embed/>
                </p:oleObj>
              </mc:Choice>
              <mc:Fallback>
                <p:oleObj name="Prism 10" r:id="rId11" imgW="3556700" imgH="2453009" progId="Prism10.Document">
                  <p:embed/>
                  <p:pic>
                    <p:nvPicPr>
                      <p:cNvPr id="34" name="Object 33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8813" y="4965147"/>
                        <a:ext cx="2955371" cy="20384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D1F565FB-9F0D-F726-8363-88E07B994374}"/>
              </a:ext>
            </a:extLst>
          </p:cNvPr>
          <p:cNvSpPr txBox="1"/>
          <p:nvPr/>
        </p:nvSpPr>
        <p:spPr>
          <a:xfrm>
            <a:off x="2872660" y="4657729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48035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5149" y="482497"/>
            <a:ext cx="4259378" cy="3675909"/>
            <a:chOff x="625565" y="4725313"/>
            <a:chExt cx="4259378" cy="367590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2456" t="27600" r="24454" b="3908"/>
            <a:stretch/>
          </p:blipFill>
          <p:spPr>
            <a:xfrm>
              <a:off x="654334" y="4849862"/>
              <a:ext cx="1955908" cy="1602386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/>
            <a:srcRect l="1887" t="27751" r="25097" b="3844"/>
            <a:stretch/>
          </p:blipFill>
          <p:spPr>
            <a:xfrm>
              <a:off x="2717089" y="4831965"/>
              <a:ext cx="2000102" cy="1638179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/>
            <a:srcRect l="2199" t="27504" r="24619" b="3538"/>
            <a:stretch/>
          </p:blipFill>
          <p:spPr>
            <a:xfrm>
              <a:off x="2742219" y="6685126"/>
              <a:ext cx="1993148" cy="163462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/>
            <a:srcRect l="2073" t="28021" r="24227" b="3574"/>
            <a:stretch/>
          </p:blipFill>
          <p:spPr>
            <a:xfrm>
              <a:off x="676470" y="6685126"/>
              <a:ext cx="1988569" cy="1613581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718859" y="4725314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NT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45094" y="6588631"/>
              <a:ext cx="582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ool 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726119" y="4725313"/>
              <a:ext cx="582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ool 2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718548" y="6588631"/>
              <a:ext cx="582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ool 3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02966" y="4917790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6.67%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39342" y="5904765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7.21%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72659" y="4937458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5.66%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09035" y="5924433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.34%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71012" y="6768200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17.12%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07388" y="7755175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79.62%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277577" y="6787866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50.48%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313953" y="7774841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45.85%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82241" y="6329189"/>
              <a:ext cx="133241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68255" y="5332012"/>
              <a:ext cx="9300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471334" y="6340628"/>
              <a:ext cx="133241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2357348" y="5343451"/>
              <a:ext cx="9300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92763" y="8170163"/>
              <a:ext cx="133241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278777" y="7172986"/>
              <a:ext cx="9300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58769" y="8185778"/>
              <a:ext cx="133241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10.05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2344783" y="7188601"/>
              <a:ext cx="9300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0E42A762-C0F3-384B-C1B0-8BD5A513BABA}"/>
              </a:ext>
            </a:extLst>
          </p:cNvPr>
          <p:cNvSpPr txBox="1"/>
          <p:nvPr/>
        </p:nvSpPr>
        <p:spPr>
          <a:xfrm>
            <a:off x="156052" y="313356"/>
            <a:ext cx="2220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94DA815-1026-63EB-8433-F16DE3187765}"/>
              </a:ext>
            </a:extLst>
          </p:cNvPr>
          <p:cNvSpPr txBox="1"/>
          <p:nvPr/>
        </p:nvSpPr>
        <p:spPr>
          <a:xfrm>
            <a:off x="156052" y="4220136"/>
            <a:ext cx="3765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6"/>
          <a:srcRect l="9239" t="25793" r="24825" b="9907"/>
          <a:stretch/>
        </p:blipFill>
        <p:spPr>
          <a:xfrm>
            <a:off x="512090" y="6505895"/>
            <a:ext cx="1764945" cy="1411957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7"/>
          <a:srcRect l="8420" t="25019" r="25070" b="9550"/>
          <a:stretch/>
        </p:blipFill>
        <p:spPr>
          <a:xfrm>
            <a:off x="2649686" y="6489503"/>
            <a:ext cx="1701185" cy="1433702"/>
          </a:xfrm>
          <a:prstGeom prst="rect">
            <a:avLst/>
          </a:prstGeom>
        </p:spPr>
      </p:pic>
      <p:grpSp>
        <p:nvGrpSpPr>
          <p:cNvPr id="54" name="Group 53"/>
          <p:cNvGrpSpPr/>
          <p:nvPr/>
        </p:nvGrpSpPr>
        <p:grpSpPr>
          <a:xfrm>
            <a:off x="381476" y="4304019"/>
            <a:ext cx="4210562" cy="1906701"/>
            <a:chOff x="381476" y="4304019"/>
            <a:chExt cx="4210562" cy="1906701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8"/>
            <a:srcRect l="8642" t="25364" r="24731" b="9915"/>
            <a:stretch/>
          </p:blipFill>
          <p:spPr>
            <a:xfrm>
              <a:off x="2633859" y="4503133"/>
              <a:ext cx="1759817" cy="1492143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9"/>
            <a:srcRect l="9588" t="25117" r="24433" b="9421"/>
            <a:stretch/>
          </p:blipFill>
          <p:spPr>
            <a:xfrm>
              <a:off x="547186" y="4506651"/>
              <a:ext cx="1729849" cy="1498072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1406127" y="4304019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NT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950252" y="4492972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49.36%</a:t>
              </a:r>
              <a:endParaRPr lang="en-US" sz="1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926972" y="5519771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41.80%</a:t>
              </a:r>
              <a:endParaRPr lang="en-US" sz="10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93856" y="5995276"/>
              <a:ext cx="119936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923" y="5038023"/>
              <a:ext cx="97654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480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042685" y="5971886"/>
              <a:ext cx="119936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0111-mNeonGreen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137529" y="5054552"/>
              <a:ext cx="97654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c480-mApple</a:t>
              </a:r>
              <a:endParaRPr lang="en-US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510763" y="4337580"/>
              <a:ext cx="582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Pool 2</a:t>
              </a:r>
              <a:endParaRPr lang="en-US" sz="1200" b="1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979760" y="4504092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9.57%</a:t>
              </a:r>
              <a:endParaRPr lang="en-US" sz="10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021048" y="5495230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83.25%</a:t>
              </a:r>
              <a:endParaRPr lang="en-US" sz="1000" dirty="0"/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901921" y="6489503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4.07%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4065376" y="7461540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.66%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3021320" y="6478035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9.83%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1911230" y="7464917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6.39%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873227" y="7911348"/>
            <a:ext cx="119936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0111-mNeonGreen</a:t>
            </a:r>
            <a:endParaRPr lang="en-US" sz="8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923" y="6992031"/>
            <a:ext cx="97654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480-mApple</a:t>
            </a:r>
            <a:endParaRPr lang="en-US" sz="8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28314" y="6287266"/>
            <a:ext cx="582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ool 1</a:t>
            </a:r>
            <a:endParaRPr lang="en-US" sz="12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3015491" y="7911348"/>
            <a:ext cx="119936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0111-mNeonGreen</a:t>
            </a:r>
            <a:endParaRPr lang="en-US" sz="8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2144311" y="6996662"/>
            <a:ext cx="97654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480-mApple</a:t>
            </a:r>
            <a:endParaRPr lang="en-US" sz="8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510763" y="6302655"/>
            <a:ext cx="582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ool 3</a:t>
            </a:r>
            <a:endParaRPr lang="en-US" sz="1200" b="1" dirty="0"/>
          </a:p>
        </p:txBody>
      </p:sp>
      <p:sp>
        <p:nvSpPr>
          <p:cNvPr id="55" name="Rectangle 54"/>
          <p:cNvSpPr/>
          <p:nvPr/>
        </p:nvSpPr>
        <p:spPr>
          <a:xfrm>
            <a:off x="396054" y="8218380"/>
            <a:ext cx="7020483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7. TS0111- and Panc480-specific </a:t>
            </a:r>
            <a:r>
              <a:rPr lang="en-US" sz="1000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RNAs</a:t>
            </a:r>
            <a:r>
              <a:rPr 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duced selective toxicity against TS0111 and Panc480, respectively.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Co-cultures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of TS0111 (labeled with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Apple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nd Panc10.05 (labeled with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NeonGreen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were treated with three different pools of TS0111-specific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(9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er pool) along with equivalent doses of non-targeting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ontrols (NT; MOI90), and flow cytometry was performed to quantify cells that were positive for either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Neon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Green or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Apple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low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ytometry analyses of one replicate on day 14 post transductions were shown.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T and Pool 1 data were also displayed in Figure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3C.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-cultures of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anc480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labeled with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Apple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nd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S0111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labeled with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NeonGreen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were treated with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either three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ifferent pools of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anc480-specific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4 </a:t>
            </a:r>
            <a:r>
              <a:rPr lang="en-US" sz="1000" dirty="0" err="1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s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er pool)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or a pool of non-targeting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gRNA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ontrols (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T),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nd flow cytometry was performed to quantify cells that were positive for either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Neon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Green or </a:t>
            </a:r>
            <a:r>
              <a:rPr lang="en-US" sz="10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Apple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Flow cytometry analyses of one replicate on day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1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st transductions were shown. NT and Pool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 </a:t>
            </a:r>
            <a:r>
              <a:rPr lang="en-US" sz="1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ata were also displayed in Figure </a:t>
            </a:r>
            <a:r>
              <a:rPr lang="en-US" sz="1000" dirty="0" smtClean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3E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52131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E8BD6BA7-85E8-BA48-FF74-D668F67B6F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92" t="10099" b="13050"/>
          <a:stretch/>
        </p:blipFill>
        <p:spPr>
          <a:xfrm>
            <a:off x="1943101" y="2224802"/>
            <a:ext cx="4248150" cy="2447713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155C611-5B9C-2868-A73E-2AB76380071D}"/>
              </a:ext>
            </a:extLst>
          </p:cNvPr>
          <p:cNvSpPr/>
          <p:nvPr/>
        </p:nvSpPr>
        <p:spPr>
          <a:xfrm>
            <a:off x="788173" y="5132860"/>
            <a:ext cx="655800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8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SB repair inhibitor increased growth inhibition of multitarget sgRNA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gRNAs with 0-16 target sites in the human genome were transduced into TS0111 and treated with either DMSO (-KU) or 1uM DNA-PK/PI3-K inhibitor, KU-0060648 (+KU). Growth inhibition was assessed us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lamarBlu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 viability assay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C339B8-13C6-8AD7-4986-21368D127BCC}"/>
              </a:ext>
            </a:extLst>
          </p:cNvPr>
          <p:cNvSpPr txBox="1"/>
          <p:nvPr/>
        </p:nvSpPr>
        <p:spPr>
          <a:xfrm rot="10800000">
            <a:off x="1573769" y="2685147"/>
            <a:ext cx="369332" cy="152702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 growth inhibi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31E99B-8D5A-7096-D9CB-8FA7FFD87928}"/>
              </a:ext>
            </a:extLst>
          </p:cNvPr>
          <p:cNvSpPr txBox="1"/>
          <p:nvPr/>
        </p:nvSpPr>
        <p:spPr>
          <a:xfrm>
            <a:off x="2628900" y="4668255"/>
            <a:ext cx="1948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. of sgRNA target site</a:t>
            </a:r>
          </a:p>
        </p:txBody>
      </p:sp>
    </p:spTree>
    <p:extLst>
      <p:ext uri="{BB962C8B-B14F-4D97-AF65-F5344CB8AC3E}">
        <p14:creationId xmlns:p14="http://schemas.microsoft.com/office/powerpoint/2010/main" val="4289016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27</TotalTime>
  <Words>1226</Words>
  <Application>Microsoft Office PowerPoint</Application>
  <PresentationFormat>Custom</PresentationFormat>
  <Paragraphs>103</Paragraphs>
  <Slides>8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DengXian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ina Shiqing Teh</dc:creator>
  <cp:lastModifiedBy>Selina Shiqing Teh</cp:lastModifiedBy>
  <cp:revision>168</cp:revision>
  <cp:lastPrinted>2023-10-02T17:28:04Z</cp:lastPrinted>
  <dcterms:created xsi:type="dcterms:W3CDTF">2022-11-07T20:20:32Z</dcterms:created>
  <dcterms:modified xsi:type="dcterms:W3CDTF">2024-04-23T18:15:06Z</dcterms:modified>
</cp:coreProperties>
</file>